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648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361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705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794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72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324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58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216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01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529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170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346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AFE1E-349A-4242-A249-524E71138B28}" type="datetimeFigureOut">
              <a:rPr lang="en-US" smtClean="0"/>
              <a:t>4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3F9181-3F7F-492A-8760-55C306910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591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6046217"/>
              </p:ext>
            </p:extLst>
          </p:nvPr>
        </p:nvGraphicFramePr>
        <p:xfrm>
          <a:off x="457200" y="76200"/>
          <a:ext cx="8077200" cy="6642354"/>
        </p:xfrm>
        <a:graphic>
          <a:graphicData uri="http://schemas.openxmlformats.org/drawingml/2006/table">
            <a:tbl>
              <a:tblPr firstRow="1" firstCol="1" bandRow="1"/>
              <a:tblGrid>
                <a:gridCol w="1978914"/>
                <a:gridCol w="840028"/>
                <a:gridCol w="610058"/>
                <a:gridCol w="1097463"/>
                <a:gridCol w="1289121"/>
                <a:gridCol w="1292352"/>
                <a:gridCol w="969264"/>
              </a:tblGrid>
              <a:tr h="196781">
                <a:tc gridSpan="7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Table S1. Summary 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of </a:t>
                      </a:r>
                      <a:r>
                        <a:rPr lang="en-US" sz="1800" b="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TCGA pan-cancer 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data</a:t>
                      </a:r>
                      <a:endParaRPr lang="en-US" sz="18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imary </a:t>
                      </a:r>
                      <a:r>
                        <a:rPr lang="en-US" sz="1100" b="1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disease type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TCGAID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Total N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imary Tumor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/>
                          <a:ea typeface="Calibri"/>
                          <a:cs typeface="Times New Roman"/>
                        </a:rPr>
                        <a:t>Normal Tissue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OS_censored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OS_event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uveal mela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UVM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8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uterine </a:t>
                      </a: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carcinosarc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UCS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51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uterine corpus </a:t>
                      </a: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endometrioid</a:t>
                      </a: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UCE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98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74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3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thymoma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THYM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2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1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hyroid carcin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HC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64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05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8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4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esticular germ cell tumor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GCT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5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1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kin cutaneous mela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KCM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04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0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sarc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SAR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58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6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7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rectum aden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READ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0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94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ostate aden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PRAD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4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9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1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51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pheochromocytoma</a:t>
                      </a: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&amp; </a:t>
                      </a: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paragangli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PCPG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8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7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7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pancreatic adenocarcin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AAD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8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7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59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ovarian serous cystaden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OV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6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62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14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4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mesotheli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MESO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8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lung squamous cell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US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5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0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9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7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lung aden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UAD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6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0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3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3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iver hepatocellular carcin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IH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2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7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2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0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brain lower grade gli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GG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1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1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6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8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acute myeloid leukemi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LAML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7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7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0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kidney papillary cell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KIRP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2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9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14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kidney clear cell carcinom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KIR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60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2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7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5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6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kidney chromophobe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KICH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9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6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51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head &amp; neck squamous cell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NS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6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1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1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8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glioblastoma multiforme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GBM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5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54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0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iffuse large B-cell lymph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DLB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8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8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olon aden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OAD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27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8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1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59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ervical &amp; </a:t>
                      </a:r>
                      <a:r>
                        <a:rPr lang="en-US" sz="100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endocervical</a:t>
                      </a: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cancer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SC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30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0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6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holangio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C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8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6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breast invasive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BRC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1203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09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1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915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28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bladder urothelial carcinoma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BLCA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426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0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204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23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2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drenocortical cancer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CC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7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79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2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7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2778" marR="427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4746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457200" y="399619"/>
            <a:ext cx="8020144" cy="877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able S2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 Summary of association between SEMA3 gene expression and patient overall survival in different cancer (P&lt;0.05)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where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“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oor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”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s increased expression of SEMA3 associates with worse survival, while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“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good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”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s increased gen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xpression associates with better survival. 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2866828" y="1479646"/>
          <a:ext cx="3410344" cy="4767072"/>
        </p:xfrm>
        <a:graphic>
          <a:graphicData uri="http://schemas.openxmlformats.org/drawingml/2006/table">
            <a:tbl>
              <a:tblPr firstRow="1" firstCol="1" bandRow="1"/>
              <a:tblGrid>
                <a:gridCol w="420922"/>
                <a:gridCol w="429253"/>
                <a:gridCol w="426183"/>
                <a:gridCol w="424868"/>
                <a:gridCol w="432760"/>
                <a:gridCol w="420922"/>
                <a:gridCol w="420922"/>
                <a:gridCol w="434514"/>
              </a:tblGrid>
              <a:tr h="266233">
                <a:tc gridSpan="8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ssociation between SEMA3 gene expression and patient overall survival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6623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ancer typ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B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E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F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MA3G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AML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C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BLC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GG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BRC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ES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C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OA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LB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BM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NS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ICH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IR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IRP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IH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UA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US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ESO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OV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AA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CPG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RA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REA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AR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KCM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CT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HCA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UCS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UCEC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11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UVM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ood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or</a:t>
                      </a:r>
                      <a:endParaRPr lang="en-US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800" dirty="0">
                        <a:effectLst/>
                        <a:latin typeface="Calibri"/>
                      </a:endParaRPr>
                    </a:p>
                  </a:txBody>
                  <a:tcPr marL="47354" marR="473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19404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/>
          <p:cNvSpPr txBox="1"/>
          <p:nvPr/>
        </p:nvSpPr>
        <p:spPr>
          <a:xfrm>
            <a:off x="1905000" y="1723175"/>
            <a:ext cx="4991100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800" kern="1200" dirty="0" smtClean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  </a:t>
            </a:r>
            <a:r>
              <a:rPr lang="pt-BR" sz="1200" kern="1200" dirty="0" smtClean="0">
                <a:solidFill>
                  <a:srgbClr val="000000"/>
                </a:solidFill>
                <a:effectLst/>
                <a:latin typeface="Arial"/>
                <a:ea typeface="Times New Roman"/>
              </a:rPr>
              <a:t>Gene         </a:t>
            </a: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HR   HR_Low95   HR_Up95   P-values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A    1.2474     1.1265       1.3813      2.13e-05 ***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B    1.0869     0.9751       1.2114       0.132283 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C    0.9132     0.8204       1.0166      0.097235 .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D    0.8839     0.8227       0.9496      0.000744 ***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E    1.0763     1.0071       1.1504      0.030173 * 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F    1.0949      0.8962      1.3375      0.374836 </a:t>
            </a:r>
            <a:endParaRPr lang="en-US" sz="1200" dirty="0">
              <a:effectLst/>
              <a:latin typeface="Times New Roman"/>
              <a:ea typeface="Times New Roman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pt-BR" sz="1200" kern="1200" dirty="0">
                <a:solidFill>
                  <a:srgbClr val="000000"/>
                </a:solidFill>
                <a:effectLst/>
                <a:latin typeface="Arial"/>
                <a:ea typeface="Times New Roman"/>
              </a:rPr>
              <a:t>SEMA3G    0.7721     0.6884       0.8660     1.00e-05 ***</a:t>
            </a:r>
            <a:endParaRPr lang="en-US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1600200" y="1828800"/>
            <a:ext cx="4724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1600200" y="5029200"/>
            <a:ext cx="4724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1371600" y="1198915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pt-BR" sz="1200" b="1" smtClean="0">
                <a:solidFill>
                  <a:srgbClr val="000000"/>
                </a:solidFill>
                <a:latin typeface="Arial"/>
                <a:ea typeface="Times New Roman"/>
              </a:rPr>
              <a:t>Table </a:t>
            </a:r>
            <a:r>
              <a:rPr lang="pt-BR" sz="1200" b="1" smtClean="0">
                <a:solidFill>
                  <a:srgbClr val="000000"/>
                </a:solidFill>
                <a:latin typeface="Arial"/>
                <a:ea typeface="Times New Roman"/>
              </a:rPr>
              <a:t>S3. </a:t>
            </a:r>
            <a:r>
              <a:rPr lang="pt-BR" sz="1200" b="1" dirty="0" smtClean="0">
                <a:solidFill>
                  <a:srgbClr val="000000"/>
                </a:solidFill>
                <a:latin typeface="Arial"/>
                <a:ea typeface="Times New Roman"/>
              </a:rPr>
              <a:t>Multivarite </a:t>
            </a:r>
            <a:r>
              <a:rPr lang="pt-BR" sz="1200" b="1" dirty="0">
                <a:solidFill>
                  <a:srgbClr val="000000"/>
                </a:solidFill>
                <a:latin typeface="Arial"/>
                <a:ea typeface="Times New Roman"/>
              </a:rPr>
              <a:t>test results for SMEA3 genes with KIRC OS</a:t>
            </a:r>
          </a:p>
        </p:txBody>
      </p:sp>
    </p:spTree>
    <p:extLst>
      <p:ext uri="{BB962C8B-B14F-4D97-AF65-F5344CB8AC3E}">
        <p14:creationId xmlns:p14="http://schemas.microsoft.com/office/powerpoint/2010/main" val="292511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493</Words>
  <Application>Microsoft Office PowerPoint</Application>
  <PresentationFormat>On-screen Show (4:3)</PresentationFormat>
  <Paragraphs>32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OS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Xiaoli</dc:creator>
  <cp:lastModifiedBy>Zhang, Xiaoli</cp:lastModifiedBy>
  <cp:revision>12</cp:revision>
  <dcterms:created xsi:type="dcterms:W3CDTF">2019-02-19T15:25:17Z</dcterms:created>
  <dcterms:modified xsi:type="dcterms:W3CDTF">2019-04-17T18:41:25Z</dcterms:modified>
</cp:coreProperties>
</file>